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2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290529-E730-706D-1A38-FE0DB39E61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AFA0FD-0722-9D16-1C21-9027AB2D7E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E45CC1-30A9-6312-A207-344FA9456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BAC7A9-C186-B6D7-9663-4EB1B88FF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23FD8D-D761-8B97-3534-CAE379026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44479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6BD56B-28B2-A28D-9BE1-82654A1B83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112FC1-4027-5396-B485-43EFF7E2F8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A4540C-A3D4-73FF-F9C2-C55DD81DA5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46A01C-A68A-A36D-2A48-719B682B7F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016530-D00A-0F33-C91F-59B2E4506D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986917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242BBC-CF83-5E63-4F88-D0E7B8EDF8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A74859-2304-F2A1-0DA2-FDAE67DF5D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D13315-A05C-4CCD-C66E-BD2147532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17A5DC-05C0-E699-6764-C6BC47042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5F393C-A6AA-3687-51B8-992B05D61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090395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E8E617-7B76-F9AF-DFBE-A27CBDAFE3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C5838E-43EC-42A7-1902-C67549F37B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E31222-1E0E-6667-1692-72E31ADDC6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FF95B5-BAEF-A785-B363-72D3EEF8A0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F86597-3F9F-DBE6-C1B0-5C6647EA3A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941090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FE5B84-FA0D-FA94-7D30-28CE77A40C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1C2FB1B-E9EE-6C21-5305-51A32F3289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2ABB2B-1A1D-496C-757D-A1334FB34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536907-04AB-BF5C-6781-0989FCBFC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2B5643-163E-C4D3-2B98-990C0980F7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164171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3E5EA3-5F6B-741F-334D-C7D1FBE104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35C51D-8795-443F-19AD-C9BA2D8AF74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CCEF7B-793B-16A0-5E4F-3E7F03A544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49F32F6-2E21-C419-B7B4-C744CDB4A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54F625-D8D0-66CB-DD03-AFA3CC207C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8552FE1-90C8-730B-D8F9-7EA8CDC42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31554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D078F9-4282-17DC-374D-2B16A33436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8DB1EA-6407-2FB0-CBCB-CCAC551879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C9431B-10FD-8040-4F7D-B1112D0782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FA6CD46-2130-2055-CB11-C63862243B2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05C0CD1-EFC9-AC77-5A9F-58811D7A4E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A2AD810-554D-808D-63F9-863E1B3E6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4711DA-B9BB-2BB5-8E8C-F8AE10900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8F5A72-E63F-0465-4AE0-378010FB6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566925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FEF67D-6AD1-9A21-2C0F-79E2D5CAD6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D86BDEB-E202-F9DA-507E-17A362A20D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0831C1-2099-51E6-7E71-EC60E5A35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2496BA-A198-F994-0A39-F0FA4B4227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56548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B8F221-165A-801A-8D02-D85AC182F1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9A1BCA9-BA67-6904-388C-7AA9C280CB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F4004B9-AF64-3BD0-1CC3-8A37D29A4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481869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D1E7FA-DA73-0A55-4816-C8F1E3FC7E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95307B-48F8-7686-CA4B-416253FC8C2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11254-110A-DA67-03DF-25DC59574F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2DB7D3F-ADBB-28CD-D25C-3645A34A8A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346DD0-B5C3-0066-F2BF-726E0C25E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E3BAAD-65ED-F779-76EC-9C9D9BB2D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77432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500598-0AB3-2CB3-9920-F0282A5DCF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C2E09E-3FB5-820E-A331-BAA0DB5D414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E696BC-E9C0-96B0-FBCC-EE9C02B4BF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17E251-E648-7C7D-D43A-781BCA1B9A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97A757-B368-6E41-59F6-BBABE54E3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A07775-430F-0763-5E4C-DEF3EB6EE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3733324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1B838C6-967F-B132-E9DC-0E12748030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l-NL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440FD3D-4D70-E739-754B-278B4215D5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l-NL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BDBB83-46A4-F0AE-0CFC-CE8AE22502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D4F441-6425-4115-9895-8AAF7295F4B8}" type="datetimeFigureOut">
              <a:rPr lang="nl-NL" smtClean="0"/>
              <a:t>03-04-2026</a:t>
            </a:fld>
            <a:endParaRPr lang="nl-NL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4CE05A-3A60-C157-32DC-5E575C2DD4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B83166-2081-8526-2F98-99BD9F3D183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60AF76-FD6C-40F9-9F5C-D0234C9B958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302994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E1F84E3-8CA3-8D51-8B69-7CB9DF7DC5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7568" y="125615"/>
            <a:ext cx="6117116" cy="660676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85BFABF-04B7-6E44-217E-7506F799B146}"/>
              </a:ext>
            </a:extLst>
          </p:cNvPr>
          <p:cNvSpPr txBox="1"/>
          <p:nvPr/>
        </p:nvSpPr>
        <p:spPr>
          <a:xfrm>
            <a:off x="6642229" y="474501"/>
            <a:ext cx="3853543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3</a:t>
            </a:r>
          </a:p>
          <a:p>
            <a:r>
              <a:rPr lang="en-US" sz="1600" dirty="0"/>
              <a:t>Factor analysis reveals that factor 6 (containing information on </a:t>
            </a:r>
            <a:r>
              <a:rPr lang="en-US" sz="1600" dirty="0" err="1"/>
              <a:t>vWf</a:t>
            </a:r>
            <a:r>
              <a:rPr lang="en-US" sz="1600" dirty="0"/>
              <a:t> and </a:t>
            </a:r>
            <a:r>
              <a:rPr lang="en-US" sz="1600" dirty="0" err="1"/>
              <a:t>mitochondriae</a:t>
            </a:r>
            <a:r>
              <a:rPr lang="en-US" sz="1600" dirty="0"/>
              <a:t>) shows the greatest variation in endothelial cell patterns of KTR. </a:t>
            </a:r>
            <a:endParaRPr lang="en-US" dirty="0"/>
          </a:p>
          <a:p>
            <a:endParaRPr lang="nl-NL" b="1" dirty="0"/>
          </a:p>
        </p:txBody>
      </p:sp>
    </p:spTree>
    <p:extLst>
      <p:ext uri="{BB962C8B-B14F-4D97-AF65-F5344CB8AC3E}">
        <p14:creationId xmlns:p14="http://schemas.microsoft.com/office/powerpoint/2010/main" val="35699259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redewold, O.W. (INT)</dc:creator>
  <cp:lastModifiedBy>Bredewold, Edwin (INT - LUMC)</cp:lastModifiedBy>
  <cp:revision>1</cp:revision>
  <dcterms:created xsi:type="dcterms:W3CDTF">2025-12-01T11:35:38Z</dcterms:created>
  <dcterms:modified xsi:type="dcterms:W3CDTF">2026-04-03T08:29:30Z</dcterms:modified>
</cp:coreProperties>
</file>